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7" d="100"/>
          <a:sy n="77" d="100"/>
        </p:scale>
        <p:origin x="-1104" y="-8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2815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79969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845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51146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741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0244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69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469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11497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3589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602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474208-4CA3-4EB2-A095-88D166367063}" type="datetimeFigureOut">
              <a:rPr lang="en-US" smtClean="0"/>
              <a:t>7/16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A6955-F5A5-4697-8354-14F79B9AEBC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3765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1526" r="84378"/>
          <a:stretch/>
        </p:blipFill>
        <p:spPr bwMode="auto">
          <a:xfrm>
            <a:off x="276497" y="1014549"/>
            <a:ext cx="3505200" cy="37099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Rectangle 4"/>
          <p:cNvSpPr/>
          <p:nvPr/>
        </p:nvSpPr>
        <p:spPr>
          <a:xfrm>
            <a:off x="990600" y="459673"/>
            <a:ext cx="57765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Leaf</a:t>
            </a:r>
            <a:endParaRPr lang="en-US" dirty="0"/>
          </a:p>
        </p:txBody>
      </p:sp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7895" r="83568" b="-5727"/>
          <a:stretch/>
        </p:blipFill>
        <p:spPr bwMode="auto">
          <a:xfrm>
            <a:off x="5029200" y="850481"/>
            <a:ext cx="3687076" cy="410251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7" name="Rectangle 6"/>
          <p:cNvSpPr/>
          <p:nvPr/>
        </p:nvSpPr>
        <p:spPr>
          <a:xfrm>
            <a:off x="5638800" y="489466"/>
            <a:ext cx="62555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 smtClean="0"/>
              <a:t>Root</a:t>
            </a:r>
            <a:endParaRPr lang="en-US" dirty="0"/>
          </a:p>
        </p:txBody>
      </p:sp>
      <p:sp>
        <p:nvSpPr>
          <p:cNvPr id="8" name="Rectangle 7"/>
          <p:cNvSpPr/>
          <p:nvPr/>
        </p:nvSpPr>
        <p:spPr>
          <a:xfrm>
            <a:off x="441767" y="5108525"/>
            <a:ext cx="8274509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4 Fig.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at map showing expression pattern of genes in leaf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left panel) and root (right panel) tissues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nder drought stress in grape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1, 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0.3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a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2, -0.7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T3, -1.0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; T4, -1,5 </a:t>
            </a:r>
            <a:r>
              <a:rPr lang="en-US" sz="14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pa</a:t>
            </a:r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811504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aisakh, Niranjan</dc:creator>
  <cp:lastModifiedBy>Baisakh, Niranjan</cp:lastModifiedBy>
  <cp:revision>1</cp:revision>
  <dcterms:created xsi:type="dcterms:W3CDTF">2015-07-17T02:52:33Z</dcterms:created>
  <dcterms:modified xsi:type="dcterms:W3CDTF">2015-07-17T02:52:53Z</dcterms:modified>
</cp:coreProperties>
</file>